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1920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73" d="100"/>
          <a:sy n="73" d="100"/>
        </p:scale>
        <p:origin x="-540" y="1488"/>
      </p:cViewPr>
      <p:guideLst>
        <p:guide orient="horz" pos="3168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646133"/>
            <a:ext cx="10363200" cy="3501813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5282989"/>
            <a:ext cx="9144000" cy="2428451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B7591-2025-4682-A9E9-A5A389808B52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70629-0A57-422C-8CD5-0F9B44D1D4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60024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B7591-2025-4682-A9E9-A5A389808B52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70629-0A57-422C-8CD5-0F9B44D1D4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4840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535517"/>
            <a:ext cx="2628900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535517"/>
            <a:ext cx="7734300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B7591-2025-4682-A9E9-A5A389808B52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70629-0A57-422C-8CD5-0F9B44D1D4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34039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B7591-2025-4682-A9E9-A5A389808B52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70629-0A57-422C-8CD5-0F9B44D1D4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84227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507618"/>
            <a:ext cx="10515600" cy="4184014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731215"/>
            <a:ext cx="10515600" cy="2200274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B7591-2025-4682-A9E9-A5A389808B52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70629-0A57-422C-8CD5-0F9B44D1D4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2716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677584"/>
            <a:ext cx="518160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677584"/>
            <a:ext cx="518160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B7591-2025-4682-A9E9-A5A389808B52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70629-0A57-422C-8CD5-0F9B44D1D4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539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35519"/>
            <a:ext cx="10515600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465706"/>
            <a:ext cx="5157787" cy="1208404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674110"/>
            <a:ext cx="5157787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465706"/>
            <a:ext cx="5183188" cy="1208404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674110"/>
            <a:ext cx="5183188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B7591-2025-4682-A9E9-A5A389808B52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70629-0A57-422C-8CD5-0F9B44D1D4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0735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B7591-2025-4682-A9E9-A5A389808B52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70629-0A57-422C-8CD5-0F9B44D1D4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13741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B7591-2025-4682-A9E9-A5A389808B52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70629-0A57-422C-8CD5-0F9B44D1D4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438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70560"/>
            <a:ext cx="3932237" cy="234696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448226"/>
            <a:ext cx="6172200" cy="7147983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017520"/>
            <a:ext cx="3932237" cy="5590329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B7591-2025-4682-A9E9-A5A389808B52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70629-0A57-422C-8CD5-0F9B44D1D4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2991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70560"/>
            <a:ext cx="3932237" cy="234696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448226"/>
            <a:ext cx="6172200" cy="7147983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017520"/>
            <a:ext cx="3932237" cy="5590329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B7591-2025-4682-A9E9-A5A389808B52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70629-0A57-422C-8CD5-0F9B44D1D4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310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535519"/>
            <a:ext cx="1051560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677584"/>
            <a:ext cx="1051560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9322649"/>
            <a:ext cx="274320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5B7591-2025-4682-A9E9-A5A389808B52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9322649"/>
            <a:ext cx="411480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9322649"/>
            <a:ext cx="274320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E70629-0A57-422C-8CD5-0F9B44D1D4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03845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18" Type="http://schemas.openxmlformats.org/officeDocument/2006/relationships/image" Target="../media/image17.jpeg"/><Relationship Id="rId3" Type="http://schemas.openxmlformats.org/officeDocument/2006/relationships/image" Target="../media/image2.jpeg"/><Relationship Id="rId21" Type="http://schemas.openxmlformats.org/officeDocument/2006/relationships/image" Target="../media/image20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20" Type="http://schemas.openxmlformats.org/officeDocument/2006/relationships/image" Target="../media/image1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19" Type="http://schemas.openxmlformats.org/officeDocument/2006/relationships/image" Target="../media/image18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Group 30"/>
          <p:cNvGrpSpPr/>
          <p:nvPr/>
        </p:nvGrpSpPr>
        <p:grpSpPr>
          <a:xfrm>
            <a:off x="3295650" y="405415"/>
            <a:ext cx="5710707" cy="7789687"/>
            <a:chOff x="1295400" y="1891315"/>
            <a:chExt cx="5710707" cy="7789687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136" t="21596" r="33307" b="27887"/>
            <a:stretch/>
          </p:blipFill>
          <p:spPr>
            <a:xfrm>
              <a:off x="1718011" y="1891316"/>
              <a:ext cx="888664" cy="183445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131" t="21972" r="30302" b="21314"/>
            <a:stretch/>
          </p:blipFill>
          <p:spPr>
            <a:xfrm>
              <a:off x="2675821" y="1891315"/>
              <a:ext cx="857447" cy="183445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633" t="15586" r="29301" b="19437"/>
            <a:stretch/>
          </p:blipFill>
          <p:spPr>
            <a:xfrm>
              <a:off x="3593127" y="1891315"/>
              <a:ext cx="855208" cy="183445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633" t="20469" r="28299" b="19811"/>
            <a:stretch/>
          </p:blipFill>
          <p:spPr>
            <a:xfrm>
              <a:off x="4515093" y="1891315"/>
              <a:ext cx="963553" cy="1834450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907" t="22159" r="28271" b="14742"/>
            <a:stretch/>
          </p:blipFill>
          <p:spPr>
            <a:xfrm>
              <a:off x="5545402" y="1891315"/>
              <a:ext cx="999120" cy="1834450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134" t="18028" r="29802" b="23568"/>
            <a:stretch/>
          </p:blipFill>
          <p:spPr>
            <a:xfrm>
              <a:off x="1732155" y="3803039"/>
              <a:ext cx="874520" cy="183445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129" t="18591" r="33057" b="20564"/>
            <a:stretch/>
          </p:blipFill>
          <p:spPr>
            <a:xfrm>
              <a:off x="2670241" y="3803039"/>
              <a:ext cx="863027" cy="1834450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627" t="16530" r="33057" b="23944"/>
            <a:stretch/>
          </p:blipFill>
          <p:spPr>
            <a:xfrm>
              <a:off x="3580249" y="3803039"/>
              <a:ext cx="921965" cy="1867436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635" t="19343" r="29801" b="22441"/>
            <a:stretch/>
          </p:blipFill>
          <p:spPr>
            <a:xfrm>
              <a:off x="4569743" y="3786546"/>
              <a:ext cx="975886" cy="1867436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387" t="15587" r="26547" b="21127"/>
            <a:stretch/>
          </p:blipFill>
          <p:spPr>
            <a:xfrm>
              <a:off x="5606255" y="3786546"/>
              <a:ext cx="930947" cy="1867436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881" t="18028" r="30302" b="20751"/>
            <a:stretch/>
          </p:blipFill>
          <p:spPr>
            <a:xfrm>
              <a:off x="1690696" y="5714762"/>
              <a:ext cx="915980" cy="1867436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132" t="13146" r="27298" b="20939"/>
            <a:stretch/>
          </p:blipFill>
          <p:spPr>
            <a:xfrm>
              <a:off x="2676289" y="5714762"/>
              <a:ext cx="856979" cy="1867436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381" t="14085" r="26797" b="22254"/>
            <a:stretch/>
          </p:blipFill>
          <p:spPr>
            <a:xfrm>
              <a:off x="3593128" y="5729221"/>
              <a:ext cx="909086" cy="1867436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883" t="14648" r="27298" b="22066"/>
            <a:stretch/>
          </p:blipFill>
          <p:spPr>
            <a:xfrm>
              <a:off x="4562076" y="5729221"/>
              <a:ext cx="969737" cy="1867436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380" t="15399" r="30552" b="17558"/>
            <a:stretch/>
          </p:blipFill>
          <p:spPr>
            <a:xfrm>
              <a:off x="5621823" y="5712107"/>
              <a:ext cx="915379" cy="1899943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330" t="21972" r="30610" b="20939"/>
            <a:stretch/>
          </p:blipFill>
          <p:spPr>
            <a:xfrm>
              <a:off x="1690696" y="7659471"/>
              <a:ext cx="915979" cy="2014754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888" t="17652" r="27298" b="14366"/>
            <a:stretch/>
          </p:blipFill>
          <p:spPr>
            <a:xfrm>
              <a:off x="2673268" y="7658059"/>
              <a:ext cx="879447" cy="2017578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382" t="12582" r="32055" b="22629"/>
            <a:stretch/>
          </p:blipFill>
          <p:spPr>
            <a:xfrm>
              <a:off x="3593127" y="7653822"/>
              <a:ext cx="947385" cy="2017578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134" t="18779" r="28549" b="16996"/>
            <a:stretch/>
          </p:blipFill>
          <p:spPr>
            <a:xfrm>
              <a:off x="4603324" y="7671896"/>
              <a:ext cx="923639" cy="2009106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384" t="15775" r="30802" b="18122"/>
            <a:stretch/>
          </p:blipFill>
          <p:spPr>
            <a:xfrm>
              <a:off x="5606255" y="7670175"/>
              <a:ext cx="930906" cy="1996988"/>
            </a:xfrm>
            <a:prstGeom prst="rect">
              <a:avLst/>
            </a:prstGeom>
          </p:spPr>
        </p:pic>
        <p:sp>
          <p:nvSpPr>
            <p:cNvPr id="2" name="TextBox 1"/>
            <p:cNvSpPr txBox="1"/>
            <p:nvPr/>
          </p:nvSpPr>
          <p:spPr>
            <a:xfrm>
              <a:off x="1876885" y="2244144"/>
              <a:ext cx="466763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SK1           ESK6          ESK12          ESK15          ESK16</a:t>
              </a:r>
            </a:p>
          </p:txBody>
        </p:sp>
        <p:sp>
          <p:nvSpPr>
            <p:cNvPr id="3" name="Rectangle 2"/>
            <p:cNvSpPr/>
            <p:nvPr/>
          </p:nvSpPr>
          <p:spPr>
            <a:xfrm>
              <a:off x="1781858" y="4034308"/>
              <a:ext cx="5224249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SK17          ESK19         ESM2           ESM4               ESM5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Rectangle 26"/>
            <p:cNvSpPr/>
            <p:nvPr/>
          </p:nvSpPr>
          <p:spPr>
            <a:xfrm>
              <a:off x="1779710" y="6015507"/>
              <a:ext cx="5224249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SM7             ESM8          ESM12          ESM14           ESM16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295400" y="7670175"/>
              <a:ext cx="52491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           </a:t>
              </a:r>
              <a:endParaRPr lang="en-US" dirty="0"/>
            </a:p>
          </p:txBody>
        </p:sp>
        <p:sp>
          <p:nvSpPr>
            <p:cNvPr id="29" name="Rectangle 28"/>
            <p:cNvSpPr/>
            <p:nvPr/>
          </p:nvSpPr>
          <p:spPr>
            <a:xfrm>
              <a:off x="1779710" y="7903712"/>
              <a:ext cx="5224249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SM17          ESM19         ESM24          ESM25           ESR15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2" name="TextBox 31"/>
          <p:cNvSpPr txBox="1"/>
          <p:nvPr/>
        </p:nvSpPr>
        <p:spPr>
          <a:xfrm>
            <a:off x="1248428" y="8592140"/>
            <a:ext cx="992505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6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6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 </a:t>
            </a:r>
            <a:r>
              <a:rPr lang="en-US" sz="1600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ualitative ammonia </a:t>
            </a:r>
            <a:r>
              <a:rPr lang="en-US" sz="1600" dirty="0" smtClean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duction. Each isolate </a:t>
            </a:r>
            <a:r>
              <a:rPr lang="en-US" sz="1600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s grown in </a:t>
            </a:r>
            <a:r>
              <a:rPr lang="en-US" sz="1600" dirty="0" smtClean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east extract peptone broth </a:t>
            </a:r>
            <a:r>
              <a:rPr lang="en-US" sz="1600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der shaking conditions </a:t>
            </a:r>
            <a:r>
              <a:rPr lang="en-US" sz="1600" dirty="0" smtClean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vernight at </a:t>
            </a:r>
            <a:r>
              <a:rPr lang="en-US" sz="1600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8°C. Then, 50 </a:t>
            </a:r>
            <a:r>
              <a:rPr lang="en-US" sz="1600" dirty="0" err="1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L</a:t>
            </a:r>
            <a:r>
              <a:rPr lang="en-US" sz="1600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10</a:t>
            </a:r>
            <a:r>
              <a:rPr lang="en-US" sz="1600" baseline="30000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US" sz="1600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 CFU </a:t>
            </a:r>
            <a:r>
              <a:rPr lang="en-US" sz="1600" dirty="0" smtClean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l</a:t>
            </a:r>
            <a:r>
              <a:rPr lang="en-US" sz="1600" baseline="30000" dirty="0" smtClean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–1</a:t>
            </a:r>
            <a:r>
              <a:rPr lang="en-US" sz="1600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culture </a:t>
            </a:r>
            <a:r>
              <a:rPr lang="en-US" sz="1600" dirty="0" smtClean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s </a:t>
            </a:r>
            <a:r>
              <a:rPr lang="en-US" sz="1600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oculated in </a:t>
            </a:r>
            <a:r>
              <a:rPr lang="en-US" sz="1600" dirty="0" smtClean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 ml </a:t>
            </a:r>
            <a:r>
              <a:rPr lang="en-US" sz="1600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ptone </a:t>
            </a:r>
            <a:r>
              <a:rPr lang="en-US" sz="1600" dirty="0" smtClean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ter </a:t>
            </a:r>
            <a:r>
              <a:rPr lang="en-US" sz="1600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incubated at 28°C. After a 72-h incubation, 1 </a:t>
            </a:r>
            <a:r>
              <a:rPr lang="en-US" sz="1600" dirty="0" smtClean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l </a:t>
            </a:r>
            <a:r>
              <a:rPr lang="en-US" sz="1600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ssler’s reagent </a:t>
            </a:r>
            <a:r>
              <a:rPr lang="en-US" sz="1600" dirty="0" smtClean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s </a:t>
            </a:r>
            <a:r>
              <a:rPr lang="en-US" sz="1600" dirty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ded. The development of yellow to brown color indicated a positive ammonia </a:t>
            </a:r>
            <a:r>
              <a:rPr lang="en-US" sz="1600" dirty="0" smtClean="0">
                <a:solidFill>
                  <a:srgbClr val="3E3D4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duction. 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94891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2</TotalTime>
  <Words>51</Words>
  <Application>Microsoft Office PowerPoint</Application>
  <PresentationFormat>Custom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jurul</dc:creator>
  <cp:lastModifiedBy>Dr. Md. Manju</cp:lastModifiedBy>
  <cp:revision>12</cp:revision>
  <dcterms:created xsi:type="dcterms:W3CDTF">2020-10-12T06:00:06Z</dcterms:created>
  <dcterms:modified xsi:type="dcterms:W3CDTF">2021-10-03T08:15:44Z</dcterms:modified>
</cp:coreProperties>
</file>